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71" d="100"/>
          <a:sy n="171" d="100"/>
        </p:scale>
        <p:origin x="1572" y="13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10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914400" y="922033"/>
            <a:ext cx="7772400" cy="1447802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200" dirty="0"/>
              <a:t>Rubidium-82 Generator Yield and Efficiency for PET Perfusion Imaging: Comparison of Two Clinical Systems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093402" y="2431908"/>
            <a:ext cx="7315200" cy="127354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 Ahmadi, MD, PhD, Ran Klein, PhD, </a:t>
            </a:r>
          </a:p>
          <a:p>
            <a:pPr marL="0" lvl="1"/>
            <a:r>
              <a:rPr lang="en-US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ard C Lewin, MD, Rob S.B. Beanlands, MD, and </a:t>
            </a:r>
          </a:p>
          <a:p>
            <a:pPr marL="0" lvl="1"/>
            <a:r>
              <a:rPr lang="en-US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bert A. </a:t>
            </a:r>
            <a:r>
              <a:rPr lang="en-US" alt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Kemp</a:t>
            </a:r>
            <a:r>
              <a:rPr lang="en-US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D</a:t>
            </a:r>
          </a:p>
          <a:p>
            <a:endParaRPr lang="en-US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63C448-335A-4879-A935-6B4FFCE25CC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9" r="30001" b="18473"/>
          <a:stretch/>
        </p:blipFill>
        <p:spPr>
          <a:xfrm>
            <a:off x="6201597" y="3767525"/>
            <a:ext cx="2209800" cy="19413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6DDC85C-FCAE-4E8E-A3E3-CC0D5905593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2818" y="3966978"/>
            <a:ext cx="2534673" cy="1679842"/>
          </a:xfrm>
          <a:prstGeom prst="rect">
            <a:avLst/>
          </a:prstGeom>
        </p:spPr>
      </p:pic>
      <p:pic>
        <p:nvPicPr>
          <p:cNvPr id="6" name="Picture 5" descr="A person wearing glasses and smiling at the camera&#10;&#10;Description automatically generated">
            <a:extLst>
              <a:ext uri="{FF2B5EF4-FFF2-40B4-BE49-F238E27FC236}">
                <a16:creationId xmlns:a16="http://schemas.microsoft.com/office/drawing/2014/main" id="{452CC796-1E92-4979-8489-F02E8E29C25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51"/>
          <a:stretch/>
        </p:blipFill>
        <p:spPr>
          <a:xfrm>
            <a:off x="1143000" y="3783927"/>
            <a:ext cx="2083118" cy="192496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28600" y="1524000"/>
            <a:ext cx="87630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Strontium-82/Rubidium-82 (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Sr/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) generators are used widely for positron emission tomography (PET) imaging of myocardial perfusion. 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baseline="30000" dirty="0"/>
              <a:t>82</a:t>
            </a:r>
            <a:r>
              <a:rPr lang="en-US" altLang="en-US" sz="2800" dirty="0"/>
              <a:t>Sr/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 generators have different shelf-lives influenced by available daily 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 isotope yield. 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The aims of the current study were to assess the isotope production efficiency (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 yield / 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Sr parent activity) of two FDA-approved 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Sr/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 generators (RUBY-FILL® and CardioGen-82®) during their clinical shelf-life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114300" y="1333924"/>
            <a:ext cx="89154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equential daily quality assurance (QA) reports from 9 CardioGen-82® and 9 RUBY-FILL® generators were reviewed over a period of 2 year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Test </a:t>
            </a:r>
            <a:r>
              <a:rPr lang="en-US" altLang="en-US" sz="2800" dirty="0" err="1"/>
              <a:t>elutions</a:t>
            </a:r>
            <a:r>
              <a:rPr lang="en-US" altLang="en-US" sz="2800" dirty="0"/>
              <a:t> were performed at different flow-rates on the RUBY-FILL® system to determine an empirical correction-factor used to convert CardioGen-82® daily QA values of 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 yield to RUBY-FILL® equivalent value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The generator yield (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) and production efficiency (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 yield / 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Sr parent activity) were compared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4343932-AE87-4C08-A1FD-33ECC5B2FB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52" y="1371600"/>
            <a:ext cx="4500813" cy="335897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FA6A4C-28AD-4857-836F-EE5E10E969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84357" y="1380085"/>
            <a:ext cx="4500813" cy="33504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1D99684-4EB4-4704-8975-030179D8077A}"/>
              </a:ext>
            </a:extLst>
          </p:cNvPr>
          <p:cNvSpPr txBox="1"/>
          <p:nvPr/>
        </p:nvSpPr>
        <p:spPr>
          <a:xfrm>
            <a:off x="58830" y="1447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EA04E7F-9B76-4527-91BC-428D04B78E7E}"/>
              </a:ext>
            </a:extLst>
          </p:cNvPr>
          <p:cNvSpPr txBox="1"/>
          <p:nvPr/>
        </p:nvSpPr>
        <p:spPr>
          <a:xfrm>
            <a:off x="4618081" y="1447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B2F682-CC77-4E63-ABAE-5973D936F4F6}"/>
              </a:ext>
            </a:extLst>
          </p:cNvPr>
          <p:cNvSpPr txBox="1"/>
          <p:nvPr/>
        </p:nvSpPr>
        <p:spPr>
          <a:xfrm>
            <a:off x="81917" y="4730579"/>
            <a:ext cx="8908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aseline="30000" dirty="0"/>
              <a:t>82</a:t>
            </a:r>
            <a:r>
              <a:rPr lang="en-US" dirty="0"/>
              <a:t>Rb daily QA activity (solid green lines) measured on RUBY-FILL® (A) and </a:t>
            </a:r>
          </a:p>
          <a:p>
            <a:pPr algn="ctr"/>
            <a:r>
              <a:rPr lang="en-US" dirty="0"/>
              <a:t>CardioGen-82® (B) generator systems. Activity is shown in </a:t>
            </a:r>
            <a:r>
              <a:rPr lang="en-US" dirty="0" err="1"/>
              <a:t>mCi</a:t>
            </a:r>
            <a:r>
              <a:rPr lang="en-US" dirty="0"/>
              <a:t> (GBq÷37) on the left </a:t>
            </a:r>
          </a:p>
          <a:p>
            <a:pPr algn="ctr"/>
            <a:r>
              <a:rPr lang="en-US" dirty="0"/>
              <a:t>axis, and as a percent (right axis) of the </a:t>
            </a:r>
            <a:r>
              <a:rPr lang="en-US" baseline="30000" dirty="0"/>
              <a:t>82</a:t>
            </a:r>
            <a:r>
              <a:rPr lang="en-US" dirty="0"/>
              <a:t>Sr parent activity (dashed greed lines) </a:t>
            </a:r>
          </a:p>
          <a:p>
            <a:pPr algn="ctr"/>
            <a:r>
              <a:rPr lang="en-US" dirty="0"/>
              <a:t>available on each day of use.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769329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5F71158-6C56-4E3D-B99D-A96A049DAA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5400" y="1315190"/>
            <a:ext cx="6107843" cy="408146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700DE04-04CA-4B66-A8A5-E2F5829AFCAB}"/>
              </a:ext>
            </a:extLst>
          </p:cNvPr>
          <p:cNvSpPr txBox="1"/>
          <p:nvPr/>
        </p:nvSpPr>
        <p:spPr>
          <a:xfrm>
            <a:off x="96139" y="5340900"/>
            <a:ext cx="904837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aseline="30000" dirty="0"/>
              <a:t>82</a:t>
            </a:r>
            <a:r>
              <a:rPr lang="en-US" dirty="0"/>
              <a:t>Rb isotope production efficiency of the RUBY-FILL® and CardioGen-82® systems </a:t>
            </a:r>
          </a:p>
          <a:p>
            <a:pPr algn="ctr"/>
            <a:r>
              <a:rPr lang="en-US" dirty="0"/>
              <a:t>over the clinical shelf-life of N=9 generators each. </a:t>
            </a:r>
            <a:r>
              <a:rPr lang="en-US" baseline="30000" dirty="0"/>
              <a:t>82</a:t>
            </a:r>
            <a:r>
              <a:rPr lang="en-US" dirty="0"/>
              <a:t>Rb yield values were measured </a:t>
            </a:r>
          </a:p>
          <a:p>
            <a:pPr algn="ctr"/>
            <a:r>
              <a:rPr lang="en-US" dirty="0"/>
              <a:t>for RUBY-FILL® (and estimated for CardioGen-82®) using 35 mL elution at 20 mL/min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800" baseline="30000" dirty="0"/>
              <a:t>82</a:t>
            </a:r>
            <a:r>
              <a:rPr lang="en-US" altLang="en-US" sz="2800" dirty="0"/>
              <a:t>Rb generator yield was significantly under-estimated using the CardioGen-82® vs RUBY-FILL® daily QA procedure. 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800" dirty="0"/>
              <a:t>When generator yield was expressed as the integrated total activity for both systems, the estimated </a:t>
            </a:r>
            <a:r>
              <a:rPr lang="en-US" altLang="en-US" sz="2800" baseline="30000" dirty="0"/>
              <a:t>82</a:t>
            </a:r>
            <a:r>
              <a:rPr lang="en-US" altLang="en-US" sz="2800" dirty="0"/>
              <a:t>Rb production efficiency of the CardioGen-82® system was ~7% lower than RUBY-FILL® over the full period of clinical use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1</TotalTime>
  <Words>508</Words>
  <Application>Microsoft Office PowerPoint</Application>
  <PresentationFormat>On-screen Show (4:3)</PresentationFormat>
  <Paragraphs>4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Rubidium-82 Generator Yield and Efficiency for PET Perfusion Imaging: Comparison of Two Clinical System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li Ahmadi</cp:lastModifiedBy>
  <cp:revision>112</cp:revision>
  <dcterms:created xsi:type="dcterms:W3CDTF">2011-04-18T21:44:13Z</dcterms:created>
  <dcterms:modified xsi:type="dcterms:W3CDTF">2020-04-10T21:02:37Z</dcterms:modified>
</cp:coreProperties>
</file>